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38950" cy="6858000"/>
  <p:notesSz cx="9144000" cy="6858000"/>
  <p:custDataLst>
    <p:tags r:id="rId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15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1360" y="-256"/>
      </p:cViewPr>
      <p:guideLst>
        <p:guide orient="horz" pos="2160"/>
        <p:guide pos="215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5000" y="1122467"/>
            <a:ext cx="5130000" cy="2387821"/>
          </a:xfrm>
        </p:spPr>
        <p:txBody>
          <a:bodyPr anchor="b"/>
          <a:lstStyle>
            <a:lvl1pPr algn="ctr">
              <a:defRPr sz="449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5000" y="3602372"/>
            <a:ext cx="5130000" cy="1655916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265" indent="0" algn="ctr">
              <a:buNone/>
              <a:defRPr sz="1495"/>
            </a:lvl2pPr>
            <a:lvl3pPr marL="683895" indent="0" algn="ctr">
              <a:buNone/>
              <a:defRPr sz="1345"/>
            </a:lvl3pPr>
            <a:lvl4pPr marL="1026160" indent="0" algn="ctr">
              <a:buNone/>
              <a:defRPr sz="1195"/>
            </a:lvl4pPr>
            <a:lvl5pPr marL="1367790" indent="0" algn="ctr">
              <a:buNone/>
              <a:defRPr sz="1195"/>
            </a:lvl5pPr>
            <a:lvl6pPr marL="1710055" indent="0" algn="ctr">
              <a:buNone/>
              <a:defRPr sz="1195"/>
            </a:lvl6pPr>
            <a:lvl7pPr marL="2051685" indent="0" algn="ctr">
              <a:buNone/>
              <a:defRPr sz="1195"/>
            </a:lvl7pPr>
            <a:lvl8pPr marL="2393950" indent="0" algn="ctr">
              <a:buNone/>
              <a:defRPr sz="1195"/>
            </a:lvl8pPr>
            <a:lvl9pPr marL="2736215" indent="0" algn="ctr">
              <a:buNone/>
              <a:defRPr sz="1195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894875" y="365159"/>
            <a:ext cx="1474875" cy="58123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0250" y="365159"/>
            <a:ext cx="4339125" cy="58123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6688" y="1709897"/>
            <a:ext cx="5899500" cy="2853002"/>
          </a:xfrm>
        </p:spPr>
        <p:txBody>
          <a:bodyPr anchor="b"/>
          <a:lstStyle>
            <a:lvl1pPr>
              <a:defRPr sz="449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6688" y="4589889"/>
            <a:ext cx="5899500" cy="1500326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1pPr>
            <a:lvl2pPr marL="342265" indent="0">
              <a:buNone/>
              <a:defRPr sz="1495">
                <a:solidFill>
                  <a:schemeClr val="tx1">
                    <a:tint val="75000"/>
                  </a:schemeClr>
                </a:solidFill>
              </a:defRPr>
            </a:lvl2pPr>
            <a:lvl3pPr marL="683895" indent="0">
              <a:buNone/>
              <a:defRPr sz="1345">
                <a:solidFill>
                  <a:schemeClr val="tx1">
                    <a:tint val="75000"/>
                  </a:schemeClr>
                </a:solidFill>
              </a:defRPr>
            </a:lvl3pPr>
            <a:lvl4pPr marL="102616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4pPr>
            <a:lvl5pPr marL="136779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5pPr>
            <a:lvl6pPr marL="171005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6pPr>
            <a:lvl7pPr marL="205168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7pPr>
            <a:lvl8pPr marL="239395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8pPr>
            <a:lvl9pPr marL="273621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0250" y="1825794"/>
            <a:ext cx="2907000" cy="435174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62750" y="1825794"/>
            <a:ext cx="2907000" cy="435174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41" y="365159"/>
            <a:ext cx="5899500" cy="132568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141" y="1681319"/>
            <a:ext cx="2893641" cy="823988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1141" y="2505307"/>
            <a:ext cx="2893641" cy="368493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62750" y="1681319"/>
            <a:ext cx="2907891" cy="823988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62750" y="2505307"/>
            <a:ext cx="2907891" cy="368493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41" y="457242"/>
            <a:ext cx="2206078" cy="1600348"/>
          </a:xfrm>
        </p:spPr>
        <p:txBody>
          <a:bodyPr anchor="b"/>
          <a:lstStyle>
            <a:lvl1pPr>
              <a:defRPr sz="239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07891" y="987517"/>
            <a:ext cx="3462750" cy="4874077"/>
          </a:xfrm>
        </p:spPr>
        <p:txBody>
          <a:bodyPr/>
          <a:lstStyle>
            <a:lvl1pPr>
              <a:defRPr sz="2395"/>
            </a:lvl1pPr>
            <a:lvl2pPr>
              <a:defRPr sz="2095"/>
            </a:lvl2pPr>
            <a:lvl3pPr>
              <a:defRPr sz="1795"/>
            </a:lvl3pPr>
            <a:lvl4pPr>
              <a:defRPr sz="1495"/>
            </a:lvl4pPr>
            <a:lvl5pPr>
              <a:defRPr sz="1495"/>
            </a:lvl5pPr>
            <a:lvl6pPr>
              <a:defRPr sz="1495"/>
            </a:lvl6pPr>
            <a:lvl7pPr>
              <a:defRPr sz="1495"/>
            </a:lvl7pPr>
            <a:lvl8pPr>
              <a:defRPr sz="1495"/>
            </a:lvl8pPr>
            <a:lvl9pPr>
              <a:defRPr sz="149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1141" y="2057591"/>
            <a:ext cx="2206078" cy="3811942"/>
          </a:xfrm>
        </p:spPr>
        <p:txBody>
          <a:bodyPr/>
          <a:lstStyle>
            <a:lvl1pPr marL="0" indent="0">
              <a:buNone/>
              <a:defRPr sz="1195"/>
            </a:lvl1pPr>
            <a:lvl2pPr marL="342265" indent="0">
              <a:buNone/>
              <a:defRPr sz="1045"/>
            </a:lvl2pPr>
            <a:lvl3pPr marL="683895" indent="0">
              <a:buNone/>
              <a:defRPr sz="900"/>
            </a:lvl3pPr>
            <a:lvl4pPr marL="1026160" indent="0">
              <a:buNone/>
              <a:defRPr sz="750"/>
            </a:lvl4pPr>
            <a:lvl5pPr marL="1367790" indent="0">
              <a:buNone/>
              <a:defRPr sz="750"/>
            </a:lvl5pPr>
            <a:lvl6pPr marL="1710055" indent="0">
              <a:buNone/>
              <a:defRPr sz="750"/>
            </a:lvl6pPr>
            <a:lvl7pPr marL="2051685" indent="0">
              <a:buNone/>
              <a:defRPr sz="750"/>
            </a:lvl7pPr>
            <a:lvl8pPr marL="2393950" indent="0">
              <a:buNone/>
              <a:defRPr sz="750"/>
            </a:lvl8pPr>
            <a:lvl9pPr marL="2736215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41" y="457242"/>
            <a:ext cx="2206078" cy="1600348"/>
          </a:xfrm>
        </p:spPr>
        <p:txBody>
          <a:bodyPr anchor="b"/>
          <a:lstStyle>
            <a:lvl1pPr>
              <a:defRPr sz="239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07891" y="987517"/>
            <a:ext cx="3462750" cy="4874077"/>
          </a:xfrm>
        </p:spPr>
        <p:txBody>
          <a:bodyPr/>
          <a:lstStyle>
            <a:lvl1pPr marL="0" indent="0">
              <a:buNone/>
              <a:defRPr sz="2395"/>
            </a:lvl1pPr>
            <a:lvl2pPr marL="342265" indent="0">
              <a:buNone/>
              <a:defRPr sz="2095"/>
            </a:lvl2pPr>
            <a:lvl3pPr marL="683895" indent="0">
              <a:buNone/>
              <a:defRPr sz="1795"/>
            </a:lvl3pPr>
            <a:lvl4pPr marL="1026160" indent="0">
              <a:buNone/>
              <a:defRPr sz="1495"/>
            </a:lvl4pPr>
            <a:lvl5pPr marL="1367790" indent="0">
              <a:buNone/>
              <a:defRPr sz="1495"/>
            </a:lvl5pPr>
            <a:lvl6pPr marL="1710055" indent="0">
              <a:buNone/>
              <a:defRPr sz="1495"/>
            </a:lvl6pPr>
            <a:lvl7pPr marL="2051685" indent="0">
              <a:buNone/>
              <a:defRPr sz="1495"/>
            </a:lvl7pPr>
            <a:lvl8pPr marL="2393950" indent="0">
              <a:buNone/>
              <a:defRPr sz="1495"/>
            </a:lvl8pPr>
            <a:lvl9pPr marL="2736215" indent="0">
              <a:buNone/>
              <a:defRPr sz="149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1141" y="2057591"/>
            <a:ext cx="2206078" cy="3811942"/>
          </a:xfrm>
        </p:spPr>
        <p:txBody>
          <a:bodyPr/>
          <a:lstStyle>
            <a:lvl1pPr marL="0" indent="0">
              <a:buNone/>
              <a:defRPr sz="1195"/>
            </a:lvl1pPr>
            <a:lvl2pPr marL="342265" indent="0">
              <a:buNone/>
              <a:defRPr sz="1045"/>
            </a:lvl2pPr>
            <a:lvl3pPr marL="683895" indent="0">
              <a:buNone/>
              <a:defRPr sz="900"/>
            </a:lvl3pPr>
            <a:lvl4pPr marL="1026160" indent="0">
              <a:buNone/>
              <a:defRPr sz="750"/>
            </a:lvl4pPr>
            <a:lvl5pPr marL="1367790" indent="0">
              <a:buNone/>
              <a:defRPr sz="750"/>
            </a:lvl5pPr>
            <a:lvl6pPr marL="1710055" indent="0">
              <a:buNone/>
              <a:defRPr sz="750"/>
            </a:lvl6pPr>
            <a:lvl7pPr marL="2051685" indent="0">
              <a:buNone/>
              <a:defRPr sz="750"/>
            </a:lvl7pPr>
            <a:lvl8pPr marL="2393950" indent="0">
              <a:buNone/>
              <a:defRPr sz="750"/>
            </a:lvl8pPr>
            <a:lvl9pPr marL="2736215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0250" y="365159"/>
            <a:ext cx="5899500" cy="13256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0250" y="1825794"/>
            <a:ext cx="5899500" cy="43517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0250" y="6356940"/>
            <a:ext cx="1539000" cy="3651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65750" y="6356940"/>
            <a:ext cx="2308500" cy="3651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30750" y="6356940"/>
            <a:ext cx="1539000" cy="3651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3895" rtl="0" eaLnBrk="1" latinLnBrk="0" hangingPunct="1">
        <a:lnSpc>
          <a:spcPct val="90000"/>
        </a:lnSpc>
        <a:spcBef>
          <a:spcPct val="0"/>
        </a:spcBef>
        <a:buNone/>
        <a:defRPr sz="32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0815" indent="-170815" algn="l" defTabSz="683895" rtl="0" eaLnBrk="1" latinLnBrk="0" hangingPunct="1">
        <a:lnSpc>
          <a:spcPct val="90000"/>
        </a:lnSpc>
        <a:spcBef>
          <a:spcPct val="150000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8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471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495" kern="1200">
          <a:solidFill>
            <a:schemeClr val="tx1"/>
          </a:solidFill>
          <a:latin typeface="+mn-lt"/>
          <a:ea typeface="+mn-ea"/>
          <a:cs typeface="+mn-cs"/>
        </a:defRPr>
      </a:lvl3pPr>
      <a:lvl4pPr marL="119697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4pPr>
      <a:lvl5pPr marL="153924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5pPr>
      <a:lvl6pPr marL="188087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22313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56476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90703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1pPr>
      <a:lvl2pPr marL="34226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2pPr>
      <a:lvl3pPr marL="68389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3pPr>
      <a:lvl4pPr marL="102616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4pPr>
      <a:lvl5pPr marL="136779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5pPr>
      <a:lvl6pPr marL="171005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05168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39395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73621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135" y="339725"/>
            <a:ext cx="6098540" cy="130429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文本框 4"/>
          <p:cNvSpPr txBox="1"/>
          <p:nvPr/>
        </p:nvSpPr>
        <p:spPr>
          <a:xfrm>
            <a:off x="530225" y="1916430"/>
            <a:ext cx="5529580" cy="9531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just" defTabSz="266700">
              <a:spcAft>
                <a:spcPct val="0"/>
              </a:spcAft>
            </a:pPr>
            <a:r>
              <a:rPr lang="en-US" altLang="zh-CN" sz="1400" b="1">
                <a:latin typeface="Times New Roman" panose="02020603050405020304"/>
                <a:ea typeface="宋体" panose="02010600030101010101" pitchFamily="2" charset="-122"/>
              </a:rPr>
              <a:t>Fig</a:t>
            </a:r>
            <a:r>
              <a:rPr lang="en-US" altLang="zh-CN" sz="1400" b="1">
                <a:latin typeface="Times New Roman" panose="02020603050405020304"/>
                <a:ea typeface="Times New Roman" panose="02020603050405020304"/>
              </a:rPr>
              <a:t>ure</a:t>
            </a:r>
            <a:r>
              <a:rPr lang="en-US" altLang="zh-CN" sz="1400" b="1">
                <a:latin typeface="Times New Roman" panose="02020603050405020304"/>
                <a:ea typeface="宋体" panose="02010600030101010101" pitchFamily="2" charset="-122"/>
              </a:rPr>
              <a:t> S</a:t>
            </a:r>
            <a:r>
              <a:rPr lang="en-US" altLang="zh-CN" sz="1400" b="1" dirty="0">
                <a:latin typeface="Times New Roman" panose="02020603050405020304"/>
                <a:ea typeface="宋体" panose="02010600030101010101" pitchFamily="2" charset="-122"/>
              </a:rPr>
              <a:t>3</a:t>
            </a:r>
            <a:r>
              <a:rPr lang="en-US" altLang="zh-CN" sz="1400" b="1">
                <a:latin typeface="Times New Roman" panose="02020603050405020304"/>
                <a:ea typeface="宋体" panose="02010600030101010101" pitchFamily="2" charset="-122"/>
              </a:rPr>
              <a:t>.</a:t>
            </a:r>
            <a:r>
              <a:rPr lang="en-US" altLang="zh-CN" sz="1400">
                <a:latin typeface="Times New Roman" panose="02020603050405020304"/>
                <a:ea typeface="宋体" panose="02010600030101010101" pitchFamily="2" charset="-122"/>
              </a:rPr>
              <a:t> </a:t>
            </a:r>
            <a:r>
              <a:rPr lang="en-US" altLang="zh-CN" sz="1400" dirty="0">
                <a:latin typeface="Times New Roman" panose="02020603050405020304"/>
                <a:ea typeface="Times New Roman" panose="02020603050405020304"/>
              </a:rPr>
              <a:t>Expression pattern of candidate gene of </a:t>
            </a:r>
            <a:r>
              <a:rPr lang="en-US" altLang="zh-CN" sz="1400" i="1" dirty="0">
                <a:latin typeface="Times New Roman" panose="02020603050405020304"/>
                <a:ea typeface="Times New Roman" panose="02020603050405020304"/>
              </a:rPr>
              <a:t>LOC_Os11g40610.</a:t>
            </a:r>
          </a:p>
          <a:p>
            <a:pPr marL="0" indent="0" algn="just" defTabSz="266700">
              <a:spcAft>
                <a:spcPct val="0"/>
              </a:spcAft>
            </a:pPr>
            <a:r>
              <a:rPr lang="en-US" altLang="zh-CN" sz="1400" dirty="0">
                <a:latin typeface="Times New Roman" panose="02020603050405020304"/>
                <a:ea typeface="Times New Roman" panose="02020603050405020304"/>
              </a:rPr>
              <a:t>Gene expression profiles in various tissues at different developmental ages or cells, and the data were obtained from http://www.mbkbase.org/. FPKM, fragments per kilobase per million, indicates gene expression level. 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WNiYTZhOWFkZTYwNzk5N2Y0ODA2ZWQ4ZTUwOWQyZmE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53</Words>
  <Application>Microsoft Office PowerPoint</Application>
  <PresentationFormat>自定义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山与海</dc:creator>
  <cp:lastModifiedBy>来圆 翟</cp:lastModifiedBy>
  <cp:revision>6</cp:revision>
  <dcterms:created xsi:type="dcterms:W3CDTF">2023-08-09T12:44:00Z</dcterms:created>
  <dcterms:modified xsi:type="dcterms:W3CDTF">2024-09-27T03:30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7147</vt:lpwstr>
  </property>
</Properties>
</file>